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87" r:id="rId2"/>
    <p:sldId id="288" r:id="rId3"/>
    <p:sldId id="281" r:id="rId4"/>
    <p:sldId id="284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A38"/>
    <a:srgbClr val="619CFF"/>
    <a:srgbClr val="F876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86" autoAdjust="0"/>
    <p:restoredTop sz="94660"/>
  </p:normalViewPr>
  <p:slideViewPr>
    <p:cSldViewPr snapToGrid="0">
      <p:cViewPr varScale="1">
        <p:scale>
          <a:sx n="90" d="100"/>
          <a:sy n="90" d="100"/>
        </p:scale>
        <p:origin x="1944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even Dooley" userId="c0ece736206443a2" providerId="LiveId" clId="{6439F3F3-8EC7-4E82-AB8B-A896CD9059EB}"/>
    <pc:docChg chg="delSld">
      <pc:chgData name="Keven Dooley" userId="c0ece736206443a2" providerId="LiveId" clId="{6439F3F3-8EC7-4E82-AB8B-A896CD9059EB}" dt="2024-10-30T04:43:29.373" v="1" actId="47"/>
      <pc:docMkLst>
        <pc:docMk/>
      </pc:docMkLst>
      <pc:sldChg chg="del">
        <pc:chgData name="Keven Dooley" userId="c0ece736206443a2" providerId="LiveId" clId="{6439F3F3-8EC7-4E82-AB8B-A896CD9059EB}" dt="2024-10-30T04:43:29.373" v="1" actId="47"/>
        <pc:sldMkLst>
          <pc:docMk/>
          <pc:sldMk cId="3427822327" sldId="261"/>
        </pc:sldMkLst>
      </pc:sldChg>
      <pc:sldChg chg="del">
        <pc:chgData name="Keven Dooley" userId="c0ece736206443a2" providerId="LiveId" clId="{6439F3F3-8EC7-4E82-AB8B-A896CD9059EB}" dt="2024-10-30T04:43:27.450" v="0" actId="47"/>
        <pc:sldMkLst>
          <pc:docMk/>
          <pc:sldMk cId="4210393630" sldId="275"/>
        </pc:sldMkLst>
      </pc:sldChg>
      <pc:sldChg chg="del">
        <pc:chgData name="Keven Dooley" userId="c0ece736206443a2" providerId="LiveId" clId="{6439F3F3-8EC7-4E82-AB8B-A896CD9059EB}" dt="2024-10-30T04:43:27.450" v="0" actId="47"/>
        <pc:sldMkLst>
          <pc:docMk/>
          <pc:sldMk cId="1660556939" sldId="278"/>
        </pc:sldMkLst>
      </pc:sldChg>
      <pc:sldChg chg="del">
        <pc:chgData name="Keven Dooley" userId="c0ece736206443a2" providerId="LiveId" clId="{6439F3F3-8EC7-4E82-AB8B-A896CD9059EB}" dt="2024-10-30T04:43:27.450" v="0" actId="47"/>
        <pc:sldMkLst>
          <pc:docMk/>
          <pc:sldMk cId="1758635325" sldId="280"/>
        </pc:sldMkLst>
      </pc:sldChg>
      <pc:sldChg chg="del">
        <pc:chgData name="Keven Dooley" userId="c0ece736206443a2" providerId="LiveId" clId="{6439F3F3-8EC7-4E82-AB8B-A896CD9059EB}" dt="2024-10-30T04:43:27.450" v="0" actId="47"/>
        <pc:sldMkLst>
          <pc:docMk/>
          <pc:sldMk cId="3426700027" sldId="289"/>
        </pc:sldMkLst>
      </pc:sldChg>
      <pc:sldChg chg="del">
        <pc:chgData name="Keven Dooley" userId="c0ece736206443a2" providerId="LiveId" clId="{6439F3F3-8EC7-4E82-AB8B-A896CD9059EB}" dt="2024-10-30T04:43:27.450" v="0" actId="47"/>
        <pc:sldMkLst>
          <pc:docMk/>
          <pc:sldMk cId="3665736873" sldId="29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350942-94CC-408F-A958-A78DA61AA858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B9340F-2F88-41B7-BC46-61913E699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130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3893E0-1164-4BF0-A3D6-B96FD499106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955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886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262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793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861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831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548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978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710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424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448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545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9E52A0-0860-4314-8875-50D61884CCEE}" type="datetimeFigureOut">
              <a:rPr lang="en-US" smtClean="0"/>
              <a:t>10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34A17DE-F19D-4C8C-A4D6-A3C5D8BE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294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5">
            <a:extLst>
              <a:ext uri="{FF2B5EF4-FFF2-40B4-BE49-F238E27FC236}">
                <a16:creationId xmlns:a16="http://schemas.microsoft.com/office/drawing/2014/main" id="{33A4EDBF-8541-B35B-3481-C5F96BB258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400014"/>
              </p:ext>
            </p:extLst>
          </p:nvPr>
        </p:nvGraphicFramePr>
        <p:xfrm>
          <a:off x="435936" y="1000098"/>
          <a:ext cx="5917019" cy="4139704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16254">
                  <a:extLst>
                    <a:ext uri="{9D8B030D-6E8A-4147-A177-3AD203B41FA5}">
                      <a16:colId xmlns:a16="http://schemas.microsoft.com/office/drawing/2014/main" val="646311796"/>
                    </a:ext>
                  </a:extLst>
                </a:gridCol>
                <a:gridCol w="1130075">
                  <a:extLst>
                    <a:ext uri="{9D8B030D-6E8A-4147-A177-3AD203B41FA5}">
                      <a16:colId xmlns:a16="http://schemas.microsoft.com/office/drawing/2014/main" val="3972772725"/>
                    </a:ext>
                  </a:extLst>
                </a:gridCol>
                <a:gridCol w="1401959">
                  <a:extLst>
                    <a:ext uri="{9D8B030D-6E8A-4147-A177-3AD203B41FA5}">
                      <a16:colId xmlns:a16="http://schemas.microsoft.com/office/drawing/2014/main" val="1384839339"/>
                    </a:ext>
                  </a:extLst>
                </a:gridCol>
                <a:gridCol w="748051">
                  <a:extLst>
                    <a:ext uri="{9D8B030D-6E8A-4147-A177-3AD203B41FA5}">
                      <a16:colId xmlns:a16="http://schemas.microsoft.com/office/drawing/2014/main" val="1574281117"/>
                    </a:ext>
                  </a:extLst>
                </a:gridCol>
                <a:gridCol w="120218">
                  <a:extLst>
                    <a:ext uri="{9D8B030D-6E8A-4147-A177-3AD203B41FA5}">
                      <a16:colId xmlns:a16="http://schemas.microsoft.com/office/drawing/2014/main" val="64572483"/>
                    </a:ext>
                  </a:extLst>
                </a:gridCol>
                <a:gridCol w="120218">
                  <a:extLst>
                    <a:ext uri="{9D8B030D-6E8A-4147-A177-3AD203B41FA5}">
                      <a16:colId xmlns:a16="http://schemas.microsoft.com/office/drawing/2014/main" val="2905027510"/>
                    </a:ext>
                  </a:extLst>
                </a:gridCol>
                <a:gridCol w="780244">
                  <a:extLst>
                    <a:ext uri="{9D8B030D-6E8A-4147-A177-3AD203B41FA5}">
                      <a16:colId xmlns:a16="http://schemas.microsoft.com/office/drawing/2014/main" val="1350966920"/>
                    </a:ext>
                  </a:extLst>
                </a:gridCol>
              </a:tblGrid>
              <a:tr h="243512">
                <a:tc gridSpan="7"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 Regression</a:t>
                      </a:r>
                    </a:p>
                  </a:txBody>
                  <a:tcPr marL="38576" marR="38576" marT="19289" marB="19289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3347072"/>
                  </a:ext>
                </a:extLst>
              </a:tr>
              <a:tr h="243512">
                <a:tc gridSpan="7"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) invasion outcome ~ richness + (1 | invader ID)</a:t>
                      </a:r>
                    </a:p>
                  </a:txBody>
                  <a:tcPr marL="38576" marR="38576" marT="19289" marB="19289"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3742251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Error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 valu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</a:t>
                      </a: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gt; |z|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6634541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ntercept)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4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8</a:t>
                      </a:r>
                    </a:p>
                  </a:txBody>
                  <a:tcPr marL="38576" marR="38576" marT="19289" marB="19289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38576" marR="38576" marT="19289" marB="19289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1005111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chness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4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04</a:t>
                      </a:r>
                    </a:p>
                  </a:txBody>
                  <a:tcPr marL="38576" marR="38576" marT="19289" marB="19289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6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</a:p>
                  </a:txBody>
                  <a:tcPr marL="38576" marR="38576" marT="19289" marB="19289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1658805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ll devianc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9.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 393 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 rowSpan="2" gridSpan="4">
                  <a:txBody>
                    <a:bodyPr/>
                    <a:lstStyle/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>
                    <a:solidFill>
                      <a:srgbClr val="E7E7E7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8911856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 devianc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.0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 392 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 gridSpan="4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2443609"/>
                  </a:ext>
                </a:extLst>
              </a:tr>
              <a:tr h="243512">
                <a:tc gridSpan="7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) invasion outcome ~ density on spent media (</a:t>
                      </a:r>
                      <a:r>
                        <a:rPr kumimoji="0" lang="en-US" sz="1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 poae</a:t>
                      </a:r>
                      <a:r>
                        <a:rPr kumimoji="0" 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38576" marR="38576" marT="19289" marB="19289"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7E7E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1686296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ntercept)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8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1</a:t>
                      </a:r>
                    </a:p>
                  </a:txBody>
                  <a:tcPr marL="38576" marR="38576" marT="19289" marB="19289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58</a:t>
                      </a:r>
                    </a:p>
                  </a:txBody>
                  <a:tcPr marL="38576" marR="38576" marT="19289" marB="19289">
                    <a:solidFill>
                      <a:srgbClr val="CBCBC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3</a:t>
                      </a:r>
                    </a:p>
                  </a:txBody>
                  <a:tcPr marL="38576" marR="38576" marT="19289" marB="19289">
                    <a:solidFill>
                      <a:srgbClr val="CBCB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7374341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sity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5</a:t>
                      </a:r>
                    </a:p>
                  </a:txBody>
                  <a:tcPr marL="38576" marR="38576" marT="19289" marB="19289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5</a:t>
                      </a:r>
                    </a:p>
                  </a:txBody>
                  <a:tcPr marL="38576" marR="38576" marT="19289" marB="19289">
                    <a:solidFill>
                      <a:srgbClr val="E7E7E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marL="38576" marR="38576" marT="19289" marB="19289"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4009150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ll devianc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.9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 89 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 rowSpan="2" gridSpan="4">
                  <a:txBody>
                    <a:bodyPr/>
                    <a:lstStyle/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>
                    <a:solidFill>
                      <a:srgbClr val="E7E7E7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6836265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 devianc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.5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 88 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 gridSpan="4" vMerge="1">
                  <a:txBody>
                    <a:bodyPr/>
                    <a:lstStyle/>
                    <a:p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7E7E7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6793732"/>
                  </a:ext>
                </a:extLst>
              </a:tr>
              <a:tr h="243512">
                <a:tc gridSpan="7">
                  <a:txBody>
                    <a:bodyPr/>
                    <a:lstStyle/>
                    <a:p>
                      <a:pPr algn="l"/>
                      <a:r>
                        <a:rPr kumimoji="0" 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) invasion outcome ~ change in density over assembly + (1 | invader ID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7E7E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8488109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ntercept)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4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0</a:t>
                      </a:r>
                    </a:p>
                  </a:txBody>
                  <a:tcPr marL="38576" marR="38576" marT="19289" marB="19289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8</a:t>
                      </a:r>
                    </a:p>
                  </a:txBody>
                  <a:tcPr marL="38576" marR="38576" marT="19289" marB="19289">
                    <a:solidFill>
                      <a:srgbClr val="E7E7E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4</a:t>
                      </a:r>
                      <a:endParaRPr 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>
                    <a:solidFill>
                      <a:srgbClr val="E7E7E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41496572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 in density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43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4</a:t>
                      </a:r>
                    </a:p>
                  </a:txBody>
                  <a:tcPr marL="38576" marR="38576" marT="19289" marB="19289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9</a:t>
                      </a:r>
                    </a:p>
                  </a:txBody>
                  <a:tcPr marL="38576" marR="38576" marT="19289" marB="19289">
                    <a:solidFill>
                      <a:srgbClr val="CBCBC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</a:p>
                  </a:txBody>
                  <a:tcPr marL="38576" marR="38576" marT="19289" marB="19289">
                    <a:solidFill>
                      <a:srgbClr val="CBCBC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0229992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ll devianc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3.7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 133 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 rowSpan="2" gridSpan="4">
                  <a:txBody>
                    <a:bodyPr/>
                    <a:lstStyle/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>
                    <a:solidFill>
                      <a:srgbClr val="E7E7E7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8815474"/>
                  </a:ext>
                </a:extLst>
              </a:tr>
              <a:tr h="24351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 devianc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.3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 132 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 gridSpan="4" vMerge="1">
                  <a:txBody>
                    <a:bodyPr/>
                    <a:lstStyle/>
                    <a:p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7E7E7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5515080"/>
                  </a:ext>
                </a:extLst>
              </a:tr>
            </a:tbl>
          </a:graphicData>
        </a:graphic>
      </p:graphicFrame>
      <p:graphicFrame>
        <p:nvGraphicFramePr>
          <p:cNvPr id="5" name="Table 8">
            <a:extLst>
              <a:ext uri="{FF2B5EF4-FFF2-40B4-BE49-F238E27FC236}">
                <a16:creationId xmlns:a16="http://schemas.microsoft.com/office/drawing/2014/main" id="{1254DD54-D5B7-050E-00D7-53557BD182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7402087"/>
              </p:ext>
            </p:extLst>
          </p:nvPr>
        </p:nvGraphicFramePr>
        <p:xfrm>
          <a:off x="435936" y="5178056"/>
          <a:ext cx="5954234" cy="132531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187902">
                  <a:extLst>
                    <a:ext uri="{9D8B030D-6E8A-4147-A177-3AD203B41FA5}">
                      <a16:colId xmlns:a16="http://schemas.microsoft.com/office/drawing/2014/main" val="668480399"/>
                    </a:ext>
                  </a:extLst>
                </a:gridCol>
                <a:gridCol w="634056">
                  <a:extLst>
                    <a:ext uri="{9D8B030D-6E8A-4147-A177-3AD203B41FA5}">
                      <a16:colId xmlns:a16="http://schemas.microsoft.com/office/drawing/2014/main" val="952716663"/>
                    </a:ext>
                  </a:extLst>
                </a:gridCol>
                <a:gridCol w="621063">
                  <a:extLst>
                    <a:ext uri="{9D8B030D-6E8A-4147-A177-3AD203B41FA5}">
                      <a16:colId xmlns:a16="http://schemas.microsoft.com/office/drawing/2014/main" val="493374997"/>
                    </a:ext>
                  </a:extLst>
                </a:gridCol>
                <a:gridCol w="555456">
                  <a:extLst>
                    <a:ext uri="{9D8B030D-6E8A-4147-A177-3AD203B41FA5}">
                      <a16:colId xmlns:a16="http://schemas.microsoft.com/office/drawing/2014/main" val="2317876829"/>
                    </a:ext>
                  </a:extLst>
                </a:gridCol>
                <a:gridCol w="744217">
                  <a:extLst>
                    <a:ext uri="{9D8B030D-6E8A-4147-A177-3AD203B41FA5}">
                      <a16:colId xmlns:a16="http://schemas.microsoft.com/office/drawing/2014/main" val="904107435"/>
                    </a:ext>
                  </a:extLst>
                </a:gridCol>
                <a:gridCol w="589624">
                  <a:extLst>
                    <a:ext uri="{9D8B030D-6E8A-4147-A177-3AD203B41FA5}">
                      <a16:colId xmlns:a16="http://schemas.microsoft.com/office/drawing/2014/main" val="1234322707"/>
                    </a:ext>
                  </a:extLst>
                </a:gridCol>
                <a:gridCol w="621916">
                  <a:extLst>
                    <a:ext uri="{9D8B030D-6E8A-4147-A177-3AD203B41FA5}">
                      <a16:colId xmlns:a16="http://schemas.microsoft.com/office/drawing/2014/main" val="1449020562"/>
                    </a:ext>
                  </a:extLst>
                </a:gridCol>
              </a:tblGrid>
              <a:tr h="265062">
                <a:tc gridSpan="5"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) Average Marginal Effects</a:t>
                      </a:r>
                    </a:p>
                  </a:txBody>
                  <a:tcPr marL="38576" marR="38576" marT="19289" marB="19289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38576" marR="38576" marT="19289" marB="19289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8608092"/>
                  </a:ext>
                </a:extLst>
              </a:tr>
              <a:tr h="26506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alu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9124892"/>
                  </a:ext>
                </a:extLst>
              </a:tr>
              <a:tr h="26506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chness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5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18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5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2419470737"/>
                  </a:ext>
                </a:extLst>
              </a:tr>
              <a:tr h="26506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sity (</a:t>
                      </a:r>
                      <a:r>
                        <a:rPr lang="en-US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. poae</a:t>
                      </a:r>
                      <a:r>
                        <a:rPr lang="en-US" sz="12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5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3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1046032278"/>
                  </a:ext>
                </a:extLst>
              </a:tr>
              <a:tr h="26506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 in density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9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7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215884821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CDED05B-20B0-6D7A-39BD-B817467C3558}"/>
              </a:ext>
            </a:extLst>
          </p:cNvPr>
          <p:cNvSpPr txBox="1"/>
          <p:nvPr/>
        </p:nvSpPr>
        <p:spPr>
          <a:xfrm>
            <a:off x="260497" y="6574242"/>
            <a:ext cx="633700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2 – Invaded community richness and resource use efficiency were associated with invasion success: Details of logistic regressions analyzing the relationships between invasion outcome with A) the richness of an invaded community (“Richness”), B) the density of a specific invader (</a:t>
            </a:r>
            <a:r>
              <a:rPr lang="en-US" sz="1200" i="1" dirty="0"/>
              <a:t>P. poae</a:t>
            </a:r>
            <a:r>
              <a:rPr lang="en-US" sz="1200" dirty="0"/>
              <a:t>) on spent-media (“Density”), and C) the change in community density between day 1 and day 6 (all density measurements represent optical density at 600nm). D) The average marginal effects of: an increase of 1 in richness, an increase of 0.1 in the density of </a:t>
            </a:r>
            <a:r>
              <a:rPr lang="en-US" sz="1200" i="1" dirty="0"/>
              <a:t>P. poae</a:t>
            </a:r>
            <a:r>
              <a:rPr lang="en-US" sz="1200" dirty="0"/>
              <a:t>, and a change in density of 0.1 are presented in the lower section of the table.</a:t>
            </a:r>
          </a:p>
        </p:txBody>
      </p:sp>
    </p:spTree>
    <p:extLst>
      <p:ext uri="{BB962C8B-B14F-4D97-AF65-F5344CB8AC3E}">
        <p14:creationId xmlns:p14="http://schemas.microsoft.com/office/powerpoint/2010/main" val="2188180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F8CDF91-B275-75F6-EDB9-D4194B9703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5370554"/>
              </p:ext>
            </p:extLst>
          </p:nvPr>
        </p:nvGraphicFramePr>
        <p:xfrm>
          <a:off x="0" y="2614869"/>
          <a:ext cx="6857999" cy="269748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842039">
                  <a:extLst>
                    <a:ext uri="{9D8B030D-6E8A-4147-A177-3AD203B41FA5}">
                      <a16:colId xmlns:a16="http://schemas.microsoft.com/office/drawing/2014/main" val="2030199133"/>
                    </a:ext>
                  </a:extLst>
                </a:gridCol>
                <a:gridCol w="618862">
                  <a:extLst>
                    <a:ext uri="{9D8B030D-6E8A-4147-A177-3AD203B41FA5}">
                      <a16:colId xmlns:a16="http://schemas.microsoft.com/office/drawing/2014/main" val="3521496805"/>
                    </a:ext>
                  </a:extLst>
                </a:gridCol>
                <a:gridCol w="576938">
                  <a:extLst>
                    <a:ext uri="{9D8B030D-6E8A-4147-A177-3AD203B41FA5}">
                      <a16:colId xmlns:a16="http://schemas.microsoft.com/office/drawing/2014/main" val="2608256970"/>
                    </a:ext>
                  </a:extLst>
                </a:gridCol>
                <a:gridCol w="637342">
                  <a:extLst>
                    <a:ext uri="{9D8B030D-6E8A-4147-A177-3AD203B41FA5}">
                      <a16:colId xmlns:a16="http://schemas.microsoft.com/office/drawing/2014/main" val="3336071339"/>
                    </a:ext>
                  </a:extLst>
                </a:gridCol>
                <a:gridCol w="576938">
                  <a:extLst>
                    <a:ext uri="{9D8B030D-6E8A-4147-A177-3AD203B41FA5}">
                      <a16:colId xmlns:a16="http://schemas.microsoft.com/office/drawing/2014/main" val="2351873821"/>
                    </a:ext>
                  </a:extLst>
                </a:gridCol>
                <a:gridCol w="637342">
                  <a:extLst>
                    <a:ext uri="{9D8B030D-6E8A-4147-A177-3AD203B41FA5}">
                      <a16:colId xmlns:a16="http://schemas.microsoft.com/office/drawing/2014/main" val="2040656757"/>
                    </a:ext>
                  </a:extLst>
                </a:gridCol>
                <a:gridCol w="576938">
                  <a:extLst>
                    <a:ext uri="{9D8B030D-6E8A-4147-A177-3AD203B41FA5}">
                      <a16:colId xmlns:a16="http://schemas.microsoft.com/office/drawing/2014/main" val="2241927280"/>
                    </a:ext>
                  </a:extLst>
                </a:gridCol>
                <a:gridCol w="618862">
                  <a:extLst>
                    <a:ext uri="{9D8B030D-6E8A-4147-A177-3AD203B41FA5}">
                      <a16:colId xmlns:a16="http://schemas.microsoft.com/office/drawing/2014/main" val="1815134621"/>
                    </a:ext>
                  </a:extLst>
                </a:gridCol>
                <a:gridCol w="576938">
                  <a:extLst>
                    <a:ext uri="{9D8B030D-6E8A-4147-A177-3AD203B41FA5}">
                      <a16:colId xmlns:a16="http://schemas.microsoft.com/office/drawing/2014/main" val="4228627621"/>
                    </a:ext>
                  </a:extLst>
                </a:gridCol>
                <a:gridCol w="618862">
                  <a:extLst>
                    <a:ext uri="{9D8B030D-6E8A-4147-A177-3AD203B41FA5}">
                      <a16:colId xmlns:a16="http://schemas.microsoft.com/office/drawing/2014/main" val="238973460"/>
                    </a:ext>
                  </a:extLst>
                </a:gridCol>
                <a:gridCol w="576938">
                  <a:extLst>
                    <a:ext uri="{9D8B030D-6E8A-4147-A177-3AD203B41FA5}">
                      <a16:colId xmlns:a16="http://schemas.microsoft.com/office/drawing/2014/main" val="254384193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Invader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seudomonas </a:t>
                      </a:r>
                    </a:p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oae</a:t>
                      </a:r>
                    </a:p>
                  </a:txBody>
                  <a:tcPr marL="4763" marR="4763" marT="47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seudomonas </a:t>
                      </a:r>
                    </a:p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oae</a:t>
                      </a:r>
                    </a:p>
                  </a:txBody>
                  <a:tcPr marL="4763" marR="4763" marT="47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seudomonas </a:t>
                      </a:r>
                    </a:p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oae</a:t>
                      </a:r>
                    </a:p>
                  </a:txBody>
                  <a:tcPr marL="4763" marR="4763" marT="47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Xanthomonas campestris</a:t>
                      </a:r>
                    </a:p>
                  </a:txBody>
                  <a:tcPr marL="4763" marR="4763" marT="47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Xanthomonas campestris</a:t>
                      </a:r>
                    </a:p>
                  </a:txBody>
                  <a:tcPr marL="4763" marR="4763" marT="47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11546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Isolate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seudomonas S91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seudomonas S105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acillus S134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763" marR="4763" marT="4763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seudarthrobacter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S5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ovosphingobi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S10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42378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Isolate </a:t>
                      </a:r>
                    </a:p>
                    <a:p>
                      <a:pPr algn="ctr"/>
                      <a:r>
                        <a:rPr lang="en-US" sz="1000" dirty="0"/>
                        <a:t>pre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Isolate ab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re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b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re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b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re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b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res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bsen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15155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Successful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Inva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8996295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Failed </a:t>
                      </a:r>
                    </a:p>
                    <a:p>
                      <a:pPr algn="ctr"/>
                      <a:r>
                        <a:rPr lang="en-US" sz="1000" dirty="0"/>
                        <a:t>Inva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9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3969404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50" dirty="0"/>
                        <a:t>Relationship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egative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ositive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egative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egative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egative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9982717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djusted </a:t>
                      </a:r>
                    </a:p>
                    <a:p>
                      <a:pPr algn="ctr"/>
                      <a:r>
                        <a:rPr lang="en-US" sz="1000" dirty="0"/>
                        <a:t>P value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56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56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77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79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79</a:t>
                      </a:r>
                    </a:p>
                  </a:txBody>
                  <a:tcPr marL="4763" marR="4763" marT="4763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36508943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F492EE1-3719-5960-D54E-ED3920A451E7}"/>
              </a:ext>
            </a:extLst>
          </p:cNvPr>
          <p:cNvSpPr txBox="1"/>
          <p:nvPr/>
        </p:nvSpPr>
        <p:spPr>
          <a:xfrm>
            <a:off x="65989" y="5477154"/>
            <a:ext cx="67260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3 – Contingency tables showing the frequency of invasion outcomes in relation to the presence or absence of particular isolates from the invaded community. Adjusted P values were determined through the </a:t>
            </a:r>
            <a:r>
              <a:rPr lang="en-US" sz="1200" dirty="0" err="1"/>
              <a:t>Benjamini</a:t>
            </a:r>
            <a:r>
              <a:rPr lang="en-US" sz="1200" dirty="0"/>
              <a:t>-Hochberg procedure.</a:t>
            </a:r>
          </a:p>
        </p:txBody>
      </p:sp>
    </p:spTree>
    <p:extLst>
      <p:ext uri="{BB962C8B-B14F-4D97-AF65-F5344CB8AC3E}">
        <p14:creationId xmlns:p14="http://schemas.microsoft.com/office/powerpoint/2010/main" val="3877393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F5A62586-0ECF-2124-20C6-C3639DB988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4281887"/>
              </p:ext>
            </p:extLst>
          </p:nvPr>
        </p:nvGraphicFramePr>
        <p:xfrm>
          <a:off x="470647" y="3444827"/>
          <a:ext cx="5916707" cy="1432727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378249">
                  <a:extLst>
                    <a:ext uri="{9D8B030D-6E8A-4147-A177-3AD203B41FA5}">
                      <a16:colId xmlns:a16="http://schemas.microsoft.com/office/drawing/2014/main" val="3468862434"/>
                    </a:ext>
                  </a:extLst>
                </a:gridCol>
                <a:gridCol w="1212660">
                  <a:extLst>
                    <a:ext uri="{9D8B030D-6E8A-4147-A177-3AD203B41FA5}">
                      <a16:colId xmlns:a16="http://schemas.microsoft.com/office/drawing/2014/main" val="401247497"/>
                    </a:ext>
                  </a:extLst>
                </a:gridCol>
                <a:gridCol w="1007374">
                  <a:extLst>
                    <a:ext uri="{9D8B030D-6E8A-4147-A177-3AD203B41FA5}">
                      <a16:colId xmlns:a16="http://schemas.microsoft.com/office/drawing/2014/main" val="1001302670"/>
                    </a:ext>
                  </a:extLst>
                </a:gridCol>
                <a:gridCol w="999710">
                  <a:extLst>
                    <a:ext uri="{9D8B030D-6E8A-4147-A177-3AD203B41FA5}">
                      <a16:colId xmlns:a16="http://schemas.microsoft.com/office/drawing/2014/main" val="3239922098"/>
                    </a:ext>
                  </a:extLst>
                </a:gridCol>
                <a:gridCol w="1318714">
                  <a:extLst>
                    <a:ext uri="{9D8B030D-6E8A-4147-A177-3AD203B41FA5}">
                      <a16:colId xmlns:a16="http://schemas.microsoft.com/office/drawing/2014/main" val="3776924720"/>
                    </a:ext>
                  </a:extLst>
                </a:gridCol>
              </a:tblGrid>
              <a:tr h="245928">
                <a:tc gridSpan="5"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) Tukey’s Honest Significance Test: invasion treatment</a:t>
                      </a:r>
                    </a:p>
                  </a:txBody>
                  <a:tcPr marL="38576" marR="38576" marT="19289" marB="19289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7834833"/>
                  </a:ext>
                </a:extLst>
              </a:tr>
              <a:tr h="449015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on treatment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differenc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 lower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 upper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p-valu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4392442"/>
                  </a:ext>
                </a:extLst>
              </a:tr>
              <a:tr h="24592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itial – lat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88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6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4291200800"/>
                  </a:ext>
                </a:extLst>
              </a:tr>
              <a:tr h="24592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ly – late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5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7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1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1715187225"/>
                  </a:ext>
                </a:extLst>
              </a:tr>
              <a:tr h="24592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ly – initial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1121576101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0C1ADCF7-3985-915B-EFCE-BE1286BECA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8001569"/>
              </p:ext>
            </p:extLst>
          </p:nvPr>
        </p:nvGraphicFramePr>
        <p:xfrm>
          <a:off x="470645" y="2327856"/>
          <a:ext cx="5916707" cy="1051161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583705">
                  <a:extLst>
                    <a:ext uri="{9D8B030D-6E8A-4147-A177-3AD203B41FA5}">
                      <a16:colId xmlns:a16="http://schemas.microsoft.com/office/drawing/2014/main" val="3241339433"/>
                    </a:ext>
                  </a:extLst>
                </a:gridCol>
                <a:gridCol w="611437">
                  <a:extLst>
                    <a:ext uri="{9D8B030D-6E8A-4147-A177-3AD203B41FA5}">
                      <a16:colId xmlns:a16="http://schemas.microsoft.com/office/drawing/2014/main" val="3557276825"/>
                    </a:ext>
                  </a:extLst>
                </a:gridCol>
                <a:gridCol w="1526424">
                  <a:extLst>
                    <a:ext uri="{9D8B030D-6E8A-4147-A177-3AD203B41FA5}">
                      <a16:colId xmlns:a16="http://schemas.microsoft.com/office/drawing/2014/main" val="3148031662"/>
                    </a:ext>
                  </a:extLst>
                </a:gridCol>
                <a:gridCol w="954620">
                  <a:extLst>
                    <a:ext uri="{9D8B030D-6E8A-4147-A177-3AD203B41FA5}">
                      <a16:colId xmlns:a16="http://schemas.microsoft.com/office/drawing/2014/main" val="676027352"/>
                    </a:ext>
                  </a:extLst>
                </a:gridCol>
                <a:gridCol w="1240521">
                  <a:extLst>
                    <a:ext uri="{9D8B030D-6E8A-4147-A177-3AD203B41FA5}">
                      <a16:colId xmlns:a16="http://schemas.microsoft.com/office/drawing/2014/main" val="2295605147"/>
                    </a:ext>
                  </a:extLst>
                </a:gridCol>
              </a:tblGrid>
              <a:tr h="271483">
                <a:tc gridSpan="5"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) One-way ANOVA: Bray-Curtis dissimilarity ~ invasion treatment</a:t>
                      </a:r>
                    </a:p>
                  </a:txBody>
                  <a:tcPr marL="38576" marR="38576" marT="19289" marB="19289"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25016412"/>
                  </a:ext>
                </a:extLst>
              </a:tr>
              <a:tr h="271483"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 of squares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414872"/>
                  </a:ext>
                </a:extLst>
              </a:tr>
              <a:tr h="2714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on treatment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6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3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837731556"/>
                  </a:ext>
                </a:extLst>
              </a:tr>
              <a:tr h="236712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s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6</a:t>
                      </a:r>
                    </a:p>
                  </a:txBody>
                  <a:tcPr marL="38576" marR="38576" marT="19289" marB="19289"/>
                </a:tc>
                <a:tc gridSpan="2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19289" marB="19289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817691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104A27F2-E481-2A2C-6959-57034BAF047F}"/>
              </a:ext>
            </a:extLst>
          </p:cNvPr>
          <p:cNvSpPr txBox="1"/>
          <p:nvPr/>
        </p:nvSpPr>
        <p:spPr>
          <a:xfrm>
            <a:off x="470647" y="4943364"/>
            <a:ext cx="591670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4 – Invasion timing affected the degree to which invasion shifted community composition: A) Mean (±1SD) Bray-Curtis dissimilarity of communities for each invasion timing treatment relative to the uninvaded controls. B) One-way ANOVA (Type III) results analyzing the relationship between Bray-Curtis dissimilarity (relative to the uninvaded communities) and invasion timing treatment. C) Tukey’s Honest Significance Test results comparing the differences in Bray-Curtis dissimilarities between the invasion timing treatments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82EB637-12FC-6BB2-A2B5-E367EEE21D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9461652"/>
              </p:ext>
            </p:extLst>
          </p:nvPr>
        </p:nvGraphicFramePr>
        <p:xfrm>
          <a:off x="470645" y="1447597"/>
          <a:ext cx="5916705" cy="81444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003837">
                  <a:extLst>
                    <a:ext uri="{9D8B030D-6E8A-4147-A177-3AD203B41FA5}">
                      <a16:colId xmlns:a16="http://schemas.microsoft.com/office/drawing/2014/main" val="3241339433"/>
                    </a:ext>
                  </a:extLst>
                </a:gridCol>
                <a:gridCol w="1204383">
                  <a:extLst>
                    <a:ext uri="{9D8B030D-6E8A-4147-A177-3AD203B41FA5}">
                      <a16:colId xmlns:a16="http://schemas.microsoft.com/office/drawing/2014/main" val="3557276825"/>
                    </a:ext>
                  </a:extLst>
                </a:gridCol>
                <a:gridCol w="1477926">
                  <a:extLst>
                    <a:ext uri="{9D8B030D-6E8A-4147-A177-3AD203B41FA5}">
                      <a16:colId xmlns:a16="http://schemas.microsoft.com/office/drawing/2014/main" val="3148031662"/>
                    </a:ext>
                  </a:extLst>
                </a:gridCol>
                <a:gridCol w="1230559">
                  <a:extLst>
                    <a:ext uri="{9D8B030D-6E8A-4147-A177-3AD203B41FA5}">
                      <a16:colId xmlns:a16="http://schemas.microsoft.com/office/drawing/2014/main" val="676027352"/>
                    </a:ext>
                  </a:extLst>
                </a:gridCol>
              </a:tblGrid>
              <a:tr h="271483">
                <a:tc gridSpan="4"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) Mean Bray-Curtis dissimilarity relative to uninvaded controls</a:t>
                      </a:r>
                    </a:p>
                  </a:txBody>
                  <a:tcPr marL="38576" marR="38576" marT="19289" marB="19289"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25016412"/>
                  </a:ext>
                </a:extLst>
              </a:tr>
              <a:tr h="271483"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on timing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itial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ly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e</a:t>
                      </a:r>
                    </a:p>
                  </a:txBody>
                  <a:tcPr marL="38576" marR="38576" marT="19289" marB="19289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414872"/>
                  </a:ext>
                </a:extLst>
              </a:tr>
              <a:tr h="2714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(±SD)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5 (±0.22)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7 (±0.21)</a:t>
                      </a:r>
                    </a:p>
                  </a:txBody>
                  <a:tcPr marL="38576" marR="38576" marT="19289" marB="19289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1 (±0.19)</a:t>
                      </a:r>
                    </a:p>
                  </a:txBody>
                  <a:tcPr marL="38576" marR="38576" marT="19289" marB="19289"/>
                </a:tc>
                <a:extLst>
                  <a:ext uri="{0D108BD9-81ED-4DB2-BD59-A6C34878D82A}">
                    <a16:rowId xmlns:a16="http://schemas.microsoft.com/office/drawing/2014/main" val="8377315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852177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0239F49-3A52-CFEA-D33B-C09B28A730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8782266"/>
              </p:ext>
            </p:extLst>
          </p:nvPr>
        </p:nvGraphicFramePr>
        <p:xfrm>
          <a:off x="636411" y="1389760"/>
          <a:ext cx="5574635" cy="119043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92144">
                  <a:extLst>
                    <a:ext uri="{9D8B030D-6E8A-4147-A177-3AD203B41FA5}">
                      <a16:colId xmlns:a16="http://schemas.microsoft.com/office/drawing/2014/main" val="3241339433"/>
                    </a:ext>
                  </a:extLst>
                </a:gridCol>
                <a:gridCol w="576087">
                  <a:extLst>
                    <a:ext uri="{9D8B030D-6E8A-4147-A177-3AD203B41FA5}">
                      <a16:colId xmlns:a16="http://schemas.microsoft.com/office/drawing/2014/main" val="3557276825"/>
                    </a:ext>
                  </a:extLst>
                </a:gridCol>
                <a:gridCol w="1438174">
                  <a:extLst>
                    <a:ext uri="{9D8B030D-6E8A-4147-A177-3AD203B41FA5}">
                      <a16:colId xmlns:a16="http://schemas.microsoft.com/office/drawing/2014/main" val="3148031662"/>
                    </a:ext>
                  </a:extLst>
                </a:gridCol>
                <a:gridCol w="899429">
                  <a:extLst>
                    <a:ext uri="{9D8B030D-6E8A-4147-A177-3AD203B41FA5}">
                      <a16:colId xmlns:a16="http://schemas.microsoft.com/office/drawing/2014/main" val="676027352"/>
                    </a:ext>
                  </a:extLst>
                </a:gridCol>
                <a:gridCol w="1168801">
                  <a:extLst>
                    <a:ext uri="{9D8B030D-6E8A-4147-A177-3AD203B41FA5}">
                      <a16:colId xmlns:a16="http://schemas.microsoft.com/office/drawing/2014/main" val="2295605147"/>
                    </a:ext>
                  </a:extLst>
                </a:gridCol>
              </a:tblGrid>
              <a:tr h="215588">
                <a:tc gridSpan="5"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) One-way ANOVA: Bray-Curtis dissimilarity ~ invasion treatment</a:t>
                      </a:r>
                    </a:p>
                  </a:txBody>
                  <a:tcPr marL="161375" marR="161375" marT="80687" marB="80687"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25016412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L="68079" marR="68079" marT="34042" marB="34042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n-US" sz="12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079" marR="68079" marT="34042" marB="34042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 of squares</a:t>
                      </a:r>
                    </a:p>
                  </a:txBody>
                  <a:tcPr marL="68079" marR="68079" marT="34042" marB="34042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8079" marR="68079" marT="34042" marB="34042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68079" marR="68079" marT="34042" marB="34042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414872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on treatment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</a:p>
                  </a:txBody>
                  <a:tcPr marL="68079" marR="68079" marT="34042" marB="34042"/>
                </a:tc>
                <a:extLst>
                  <a:ext uri="{0D108BD9-81ED-4DB2-BD59-A6C34878D82A}">
                    <a16:rowId xmlns:a16="http://schemas.microsoft.com/office/drawing/2014/main" val="837731556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s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60</a:t>
                      </a:r>
                    </a:p>
                  </a:txBody>
                  <a:tcPr marL="68079" marR="68079" marT="34042" marB="34042"/>
                </a:tc>
                <a:tc gridSpan="2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375" marR="161375" marT="80687" marB="80687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817691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9D6DFA4-2D32-A57C-FC80-11CE2407FF4B}"/>
              </a:ext>
            </a:extLst>
          </p:cNvPr>
          <p:cNvSpPr txBox="1"/>
          <p:nvPr/>
        </p:nvSpPr>
        <p:spPr>
          <a:xfrm>
            <a:off x="646953" y="5649019"/>
            <a:ext cx="556409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5 – Invader growth on spent media is a significant covariate in the relationship between invasion timing and outcome: A) One-way ANOVA results from supplementary table 3, for reference. B) One-way ANCOVA including pre-invasion community richness as a covariate. C) One-way ANCOVA including invader growth on spent media as a covariate (limited to “early” and “late” invasion treatments).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98DA992-6C23-2184-C453-01E10E17B1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9388830"/>
              </p:ext>
            </p:extLst>
          </p:nvPr>
        </p:nvGraphicFramePr>
        <p:xfrm>
          <a:off x="636412" y="2687593"/>
          <a:ext cx="5574635" cy="137331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92142">
                  <a:extLst>
                    <a:ext uri="{9D8B030D-6E8A-4147-A177-3AD203B41FA5}">
                      <a16:colId xmlns:a16="http://schemas.microsoft.com/office/drawing/2014/main" val="3241339433"/>
                    </a:ext>
                  </a:extLst>
                </a:gridCol>
                <a:gridCol w="576087">
                  <a:extLst>
                    <a:ext uri="{9D8B030D-6E8A-4147-A177-3AD203B41FA5}">
                      <a16:colId xmlns:a16="http://schemas.microsoft.com/office/drawing/2014/main" val="3557276825"/>
                    </a:ext>
                  </a:extLst>
                </a:gridCol>
                <a:gridCol w="1438174">
                  <a:extLst>
                    <a:ext uri="{9D8B030D-6E8A-4147-A177-3AD203B41FA5}">
                      <a16:colId xmlns:a16="http://schemas.microsoft.com/office/drawing/2014/main" val="3148031662"/>
                    </a:ext>
                  </a:extLst>
                </a:gridCol>
                <a:gridCol w="899431">
                  <a:extLst>
                    <a:ext uri="{9D8B030D-6E8A-4147-A177-3AD203B41FA5}">
                      <a16:colId xmlns:a16="http://schemas.microsoft.com/office/drawing/2014/main" val="676027352"/>
                    </a:ext>
                  </a:extLst>
                </a:gridCol>
                <a:gridCol w="1168801">
                  <a:extLst>
                    <a:ext uri="{9D8B030D-6E8A-4147-A177-3AD203B41FA5}">
                      <a16:colId xmlns:a16="http://schemas.microsoft.com/office/drawing/2014/main" val="2295605147"/>
                    </a:ext>
                  </a:extLst>
                </a:gridCol>
              </a:tblGrid>
              <a:tr h="215588">
                <a:tc gridSpan="5"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) One-way ANCOVA: Bray-Curtis dissimilarity ~ invasion treatment + richness</a:t>
                      </a:r>
                    </a:p>
                  </a:txBody>
                  <a:tcPr marL="161375" marR="161375" marT="80687" marB="80687"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25016412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on treatment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</a:p>
                  </a:txBody>
                  <a:tcPr marL="68079" marR="68079" marT="34042" marB="34042"/>
                </a:tc>
                <a:extLst>
                  <a:ext uri="{0D108BD9-81ED-4DB2-BD59-A6C34878D82A}">
                    <a16:rowId xmlns:a16="http://schemas.microsoft.com/office/drawing/2014/main" val="837731556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chness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2</a:t>
                      </a:r>
                    </a:p>
                  </a:txBody>
                  <a:tcPr marL="68079" marR="68079" marT="34042" marB="34042"/>
                </a:tc>
                <a:extLst>
                  <a:ext uri="{0D108BD9-81ED-4DB2-BD59-A6C34878D82A}">
                    <a16:rowId xmlns:a16="http://schemas.microsoft.com/office/drawing/2014/main" val="813476780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s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0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60</a:t>
                      </a:r>
                    </a:p>
                  </a:txBody>
                  <a:tcPr marL="68079" marR="68079" marT="34042" marB="34042"/>
                </a:tc>
                <a:tc gridSpan="2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375" marR="161375" marT="80687" marB="80687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8176919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D9C38523-70C6-BDEF-4C08-F3D05B9DF6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374424"/>
              </p:ext>
            </p:extLst>
          </p:nvPr>
        </p:nvGraphicFramePr>
        <p:xfrm>
          <a:off x="636412" y="4168306"/>
          <a:ext cx="5574635" cy="137331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92142">
                  <a:extLst>
                    <a:ext uri="{9D8B030D-6E8A-4147-A177-3AD203B41FA5}">
                      <a16:colId xmlns:a16="http://schemas.microsoft.com/office/drawing/2014/main" val="3241339433"/>
                    </a:ext>
                  </a:extLst>
                </a:gridCol>
                <a:gridCol w="576087">
                  <a:extLst>
                    <a:ext uri="{9D8B030D-6E8A-4147-A177-3AD203B41FA5}">
                      <a16:colId xmlns:a16="http://schemas.microsoft.com/office/drawing/2014/main" val="3557276825"/>
                    </a:ext>
                  </a:extLst>
                </a:gridCol>
                <a:gridCol w="1438174">
                  <a:extLst>
                    <a:ext uri="{9D8B030D-6E8A-4147-A177-3AD203B41FA5}">
                      <a16:colId xmlns:a16="http://schemas.microsoft.com/office/drawing/2014/main" val="3148031662"/>
                    </a:ext>
                  </a:extLst>
                </a:gridCol>
                <a:gridCol w="899431">
                  <a:extLst>
                    <a:ext uri="{9D8B030D-6E8A-4147-A177-3AD203B41FA5}">
                      <a16:colId xmlns:a16="http://schemas.microsoft.com/office/drawing/2014/main" val="676027352"/>
                    </a:ext>
                  </a:extLst>
                </a:gridCol>
                <a:gridCol w="1168801">
                  <a:extLst>
                    <a:ext uri="{9D8B030D-6E8A-4147-A177-3AD203B41FA5}">
                      <a16:colId xmlns:a16="http://schemas.microsoft.com/office/drawing/2014/main" val="2295605147"/>
                    </a:ext>
                  </a:extLst>
                </a:gridCol>
              </a:tblGrid>
              <a:tr h="215588">
                <a:tc gridSpan="5"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) One-way ANCOVA: Bray-Curtis dissimilarity ~ invasion treatment + spent media growth</a:t>
                      </a:r>
                    </a:p>
                  </a:txBody>
                  <a:tcPr marL="161375" marR="161375" marT="80687" marB="80687"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25016412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on treatment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4</a:t>
                      </a:r>
                    </a:p>
                  </a:txBody>
                  <a:tcPr marL="68079" marR="68079" marT="34042" marB="34042"/>
                </a:tc>
                <a:extLst>
                  <a:ext uri="{0D108BD9-81ED-4DB2-BD59-A6C34878D82A}">
                    <a16:rowId xmlns:a16="http://schemas.microsoft.com/office/drawing/2014/main" val="837731556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nt media growth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</a:p>
                  </a:txBody>
                  <a:tcPr marL="68079" marR="68079" marT="34042" marB="34042"/>
                </a:tc>
                <a:extLst>
                  <a:ext uri="{0D108BD9-81ED-4DB2-BD59-A6C34878D82A}">
                    <a16:rowId xmlns:a16="http://schemas.microsoft.com/office/drawing/2014/main" val="813476780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s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4</a:t>
                      </a:r>
                    </a:p>
                  </a:txBody>
                  <a:tcPr marL="68079" marR="68079" marT="34042" marB="3404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9</a:t>
                      </a:r>
                    </a:p>
                  </a:txBody>
                  <a:tcPr marL="68079" marR="68079" marT="34042" marB="34042"/>
                </a:tc>
                <a:tc gridSpan="2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375" marR="161375" marT="80687" marB="80687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81769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08023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96</TotalTime>
  <Words>772</Words>
  <Application>Microsoft Office PowerPoint</Application>
  <PresentationFormat>Letter Paper (8.5x11 in)</PresentationFormat>
  <Paragraphs>241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ptos Narrow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 and tables</dc:title>
  <dc:creator>Keven Dooley</dc:creator>
  <cp:lastModifiedBy>Keven Dooley</cp:lastModifiedBy>
  <cp:revision>2</cp:revision>
  <dcterms:created xsi:type="dcterms:W3CDTF">2024-03-16T19:10:47Z</dcterms:created>
  <dcterms:modified xsi:type="dcterms:W3CDTF">2024-10-30T04:43:30Z</dcterms:modified>
</cp:coreProperties>
</file>